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3446145" y="6238875"/>
            <a:ext cx="5883275" cy="1655445"/>
          </a:xfrm>
        </p:spPr>
        <p:txBody>
          <a:bodyPr/>
          <a:p>
            <a:r>
              <a:rPr lang="zh-CN" altLang="en-US" sz="1600" b="1">
                <a:latin typeface="Times New Roman" panose="02020603050405020304" charset="0"/>
                <a:cs typeface="Times New Roman" panose="02020603050405020304" charset="0"/>
              </a:rPr>
              <a:t>Figure S1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  Genetic map of the 148 BC4F3 population. The black stripe shows the distribution of markers on the 10 chromosomes.</a:t>
            </a:r>
            <a:endParaRPr lang="zh-CN" altLang="en-US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dditional fil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32205" y="39370"/>
            <a:ext cx="9957435" cy="619950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DOC_GUID" val="{c9553b6a-0d74-4d23-b18e-d6439916530b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WPS 演示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莫天诺</cp:lastModifiedBy>
  <cp:revision>6</cp:revision>
  <dcterms:created xsi:type="dcterms:W3CDTF">2019-04-10T03:13:00Z</dcterms:created>
  <dcterms:modified xsi:type="dcterms:W3CDTF">2020-01-04T07:36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39</vt:lpwstr>
  </property>
</Properties>
</file>